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3" r:id="rId2"/>
    <p:sldId id="261" r:id="rId3"/>
    <p:sldId id="262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47EBC22-360C-066A-D7A7-C8BE49686BAC}" name="Brooke Keating" initials="BK" userId="6febf4edba21f79b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990"/>
    <p:restoredTop sz="94656"/>
  </p:normalViewPr>
  <p:slideViewPr>
    <p:cSldViewPr snapToGrid="0">
      <p:cViewPr varScale="1">
        <p:scale>
          <a:sx n="74" d="100"/>
          <a:sy n="74" d="100"/>
        </p:scale>
        <p:origin x="305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8/10/relationships/authors" Target="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718A-AA21-E346-9F1A-FA53956CB76B}" type="datetimeFigureOut">
              <a:rPr lang="en-US" smtClean="0"/>
              <a:t>5/3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59FDB-2872-7645-8A71-AFD352DB9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355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718A-AA21-E346-9F1A-FA53956CB76B}" type="datetimeFigureOut">
              <a:rPr lang="en-US" smtClean="0"/>
              <a:t>5/3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59FDB-2872-7645-8A71-AFD352DB9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751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718A-AA21-E346-9F1A-FA53956CB76B}" type="datetimeFigureOut">
              <a:rPr lang="en-US" smtClean="0"/>
              <a:t>5/3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59FDB-2872-7645-8A71-AFD352DB9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0363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718A-AA21-E346-9F1A-FA53956CB76B}" type="datetimeFigureOut">
              <a:rPr lang="en-US" smtClean="0"/>
              <a:t>5/3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59FDB-2872-7645-8A71-AFD352DB9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4450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718A-AA21-E346-9F1A-FA53956CB76B}" type="datetimeFigureOut">
              <a:rPr lang="en-US" smtClean="0"/>
              <a:t>5/3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59FDB-2872-7645-8A71-AFD352DB9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7958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718A-AA21-E346-9F1A-FA53956CB76B}" type="datetimeFigureOut">
              <a:rPr lang="en-US" smtClean="0"/>
              <a:t>5/3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59FDB-2872-7645-8A71-AFD352DB9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04537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718A-AA21-E346-9F1A-FA53956CB76B}" type="datetimeFigureOut">
              <a:rPr lang="en-US" smtClean="0"/>
              <a:t>5/31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59FDB-2872-7645-8A71-AFD352DB9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48739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718A-AA21-E346-9F1A-FA53956CB76B}" type="datetimeFigureOut">
              <a:rPr lang="en-US" smtClean="0"/>
              <a:t>5/31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59FDB-2872-7645-8A71-AFD352DB9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1931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718A-AA21-E346-9F1A-FA53956CB76B}" type="datetimeFigureOut">
              <a:rPr lang="en-US" smtClean="0"/>
              <a:t>5/31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59FDB-2872-7645-8A71-AFD352DB9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8823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718A-AA21-E346-9F1A-FA53956CB76B}" type="datetimeFigureOut">
              <a:rPr lang="en-US" smtClean="0"/>
              <a:t>5/3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59FDB-2872-7645-8A71-AFD352DB9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594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718A-AA21-E346-9F1A-FA53956CB76B}" type="datetimeFigureOut">
              <a:rPr lang="en-US" smtClean="0"/>
              <a:t>5/3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59FDB-2872-7645-8A71-AFD352DB9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7549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E8C718A-AA21-E346-9F1A-FA53956CB76B}" type="datetimeFigureOut">
              <a:rPr lang="en-US" smtClean="0"/>
              <a:t>5/3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3559FDB-2872-7645-8A71-AFD352DB9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95858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9CC4C92-5E8A-95F6-F86E-FAA2FA6C01C4}"/>
              </a:ext>
            </a:extLst>
          </p:cNvPr>
          <p:cNvSpPr txBox="1"/>
          <p:nvPr/>
        </p:nvSpPr>
        <p:spPr>
          <a:xfrm>
            <a:off x="219973" y="251713"/>
            <a:ext cx="6418053" cy="83869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Method- Single cell RNA sequencing </a:t>
            </a:r>
            <a:endParaRPr lang="en-SG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</a:p>
          <a:p>
            <a:endParaRPr lang="en-SG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AU" sz="1100" i="1" dirty="0">
                <a:latin typeface="Arial" panose="020B0604020202020204" pitchFamily="34" charset="0"/>
                <a:cs typeface="Arial" panose="020B0604020202020204" pitchFamily="34" charset="0"/>
              </a:rPr>
              <a:t>Single-cell blood RNA sequencing method</a:t>
            </a:r>
            <a:endParaRPr lang="en-SG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Red blood cells were depleted from whole blood by immunomagnetic negative selection, using the </a:t>
            </a:r>
            <a:r>
              <a:rPr lang="en-AU" sz="1100" dirty="0" err="1">
                <a:latin typeface="Arial" panose="020B0604020202020204" pitchFamily="34" charset="0"/>
                <a:cs typeface="Arial" panose="020B0604020202020204" pitchFamily="34" charset="0"/>
              </a:rPr>
              <a:t>EasySep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™ RBC depletion reagent protocol (</a:t>
            </a:r>
            <a:r>
              <a:rPr lang="en-AU" sz="1100" dirty="0" err="1">
                <a:latin typeface="Arial" panose="020B0604020202020204" pitchFamily="34" charset="0"/>
                <a:cs typeface="Arial" panose="020B0604020202020204" pitchFamily="34" charset="0"/>
              </a:rPr>
              <a:t>catalog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 #18000), preserving all leukocyte populations, including granulocytes. 3 HIVE devices (CLX version) (individual samples from 1 </a:t>
            </a:r>
            <a:r>
              <a:rPr lang="en-AU" sz="1100">
                <a:latin typeface="Arial" panose="020B0604020202020204" pitchFamily="34" charset="0"/>
                <a:cs typeface="Arial" panose="020B0604020202020204" pitchFamily="34" charset="0"/>
              </a:rPr>
              <a:t>patient and 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2 controls) were each loaded with approximately 30,000 cells in 1 mL of DPBS + 1% FBS, followed by 3 mL of cell media (DPBS + 1% FBS). The leukocytes were loaded into the HIVE system within an hour of blood sampling from all individuals to minimize neutrophil activation. Single cells settled into </a:t>
            </a:r>
            <a:r>
              <a:rPr lang="en-AU" sz="1100" dirty="0" err="1">
                <a:latin typeface="Arial" panose="020B0604020202020204" pitchFamily="34" charset="0"/>
                <a:cs typeface="Arial" panose="020B0604020202020204" pitchFamily="34" charset="0"/>
              </a:rPr>
              <a:t>picowells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 within the HIVE devices, which contained 3' transcript-capture beads. HIVEs were centrifuged at 30 x g for 3 minutes to ensure cell settling. Following media removal, HIVEs were washed twice with 2 mL of sample wash solution. After removing the wash solution, 2 mL of cell preservation solution was added, and the cell-loaded HIVEs were frozen at -80°C (Honeycomb Biotechnologies, Inc. USA Sample Capture protocol).</a:t>
            </a:r>
          </a:p>
          <a:p>
            <a:endParaRPr lang="en-AU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Frozen devices were then shipped to the Australian Genome Research Facility Ltd (AGRF Ltd, Westmead) for single-cell next-generation sequencing (NGS) library preparation, according to the manufacturer's protocol (Honeycomb Biotechnologies, Inc. USA Sample Capture protocol).</a:t>
            </a:r>
          </a:p>
          <a:p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. HIVE devices were sealed with a semi-permeable membrane, enabling on-device lysis and hybridization. Beads with captured transcripts were extracted from the HIVE device by centrifugation, and subsequent library preparation steps were performed in a 96-well plate format. Library size distribution and quality were assessed using a </a:t>
            </a:r>
            <a:r>
              <a:rPr lang="en-AU" sz="1100" dirty="0" err="1">
                <a:latin typeface="Arial" panose="020B0604020202020204" pitchFamily="34" charset="0"/>
                <a:cs typeface="Arial" panose="020B0604020202020204" pitchFamily="34" charset="0"/>
              </a:rPr>
              <a:t>TapeStation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 2200 platform with a D5000 </a:t>
            </a:r>
            <a:r>
              <a:rPr lang="en-AU" sz="1100" dirty="0" err="1">
                <a:latin typeface="Arial" panose="020B0604020202020204" pitchFamily="34" charset="0"/>
                <a:cs typeface="Arial" panose="020B0604020202020204" pitchFamily="34" charset="0"/>
              </a:rPr>
              <a:t>ScreenTape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 System (Agilent Technologies, Santa Clara, CA, USA). The concentration of final pooled libraries was determined by qPCR. Final HIVE scRNA-seq libraries were sequenced on an Illumina </a:t>
            </a:r>
            <a:r>
              <a:rPr lang="en-AU" sz="1100" dirty="0" err="1">
                <a:latin typeface="Arial" panose="020B0604020202020204" pitchFamily="34" charset="0"/>
                <a:cs typeface="Arial" panose="020B0604020202020204" pitchFamily="34" charset="0"/>
              </a:rPr>
              <a:t>NovaSeq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 X sequencer (AGRF Ltd, Melbourne) using kit-specific primers.</a:t>
            </a:r>
            <a:endParaRPr lang="en-SG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en-SG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AU" sz="1100" i="1" dirty="0">
                <a:latin typeface="Arial" panose="020B0604020202020204" pitchFamily="34" charset="0"/>
                <a:cs typeface="Arial" panose="020B0604020202020204" pitchFamily="34" charset="0"/>
              </a:rPr>
              <a:t>Single-cell RNA sequencing bioinformatic analysis </a:t>
            </a:r>
            <a:endParaRPr lang="en-SG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Cells with a high mitochondrial transcript ratio (&gt;0.15) were excluded. Normalization was performed using </a:t>
            </a:r>
            <a:r>
              <a:rPr lang="en-AU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SCTransform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 and immune cell types were assigned with </a:t>
            </a:r>
            <a:r>
              <a:rPr lang="en-AU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scType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AU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scPred</a:t>
            </a:r>
            <a:r>
              <a:rPr lang="en-AU" sz="1100" i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 Merged data were then split by cell type and separately normalized, scaled, and integrated between patients using </a:t>
            </a:r>
            <a:r>
              <a:rPr lang="en-AU" sz="1100" i="1" dirty="0">
                <a:latin typeface="Arial" panose="020B0604020202020204" pitchFamily="34" charset="0"/>
                <a:cs typeface="Arial" panose="020B0604020202020204" pitchFamily="34" charset="0"/>
              </a:rPr>
              <a:t>harmony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, then UMAP (uniform manifold approximation and</a:t>
            </a:r>
            <a:r>
              <a:rPr lang="en-AU" sz="1100" i="1" dirty="0">
                <a:latin typeface="Arial" panose="020B0604020202020204" pitchFamily="34" charset="0"/>
                <a:cs typeface="Arial" panose="020B0604020202020204" pitchFamily="34" charset="0"/>
              </a:rPr>
              <a:t> projection) 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projections were made using the first 30 dimensions. Differentially expressed genes were identified using </a:t>
            </a:r>
            <a:r>
              <a:rPr lang="en-AU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FindMarkers</a:t>
            </a:r>
            <a:r>
              <a:rPr lang="en-AU" sz="1100" i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SG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en-SG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AU" sz="1100" i="1" dirty="0">
                <a:latin typeface="Arial" panose="020B0604020202020204" pitchFamily="34" charset="0"/>
                <a:cs typeface="Arial" panose="020B0604020202020204" pitchFamily="34" charset="0"/>
              </a:rPr>
              <a:t>Gene set enrichment (GSEA) pathway analyses </a:t>
            </a:r>
            <a:endParaRPr lang="en-SG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The genes were ranked based on their logFC. Enriched gene sets were identified based on a running sum statistic (normalized enrichment score (NES)) and statistical significance, based on the false discovery rate (FDR). Significant GSEA GO pathways (FDR &lt;0.05) were further simplified using the </a:t>
            </a:r>
            <a:r>
              <a:rPr lang="en-AU" sz="1100" i="1" dirty="0">
                <a:latin typeface="Arial" panose="020B0604020202020204" pitchFamily="34" charset="0"/>
                <a:cs typeface="Arial" panose="020B0604020202020204" pitchFamily="34" charset="0"/>
              </a:rPr>
              <a:t>simplify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 function in clusterProfiler. </a:t>
            </a:r>
            <a:endParaRPr lang="en-SG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en-SG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AU" sz="1100" i="1" dirty="0">
                <a:latin typeface="Arial" panose="020B0604020202020204" pitchFamily="34" charset="0"/>
                <a:cs typeface="Arial" panose="020B0604020202020204" pitchFamily="34" charset="0"/>
              </a:rPr>
              <a:t>Bar/dot and connectivity network plots</a:t>
            </a:r>
            <a:endParaRPr lang="en-SG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ar and dot plots of GSEA gene ontology (GO) results were plotted using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ggplot2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ackage. 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The top 5 up-regulated and down-regulated GSEA GO post-simplified pathways, for each cell type were selected as representative GO terms. For the dot plot of 8 cell types, only the GO terms present in more than 2 cell types in SC patient versus control was mapped. </a:t>
            </a:r>
            <a:endParaRPr lang="en-SG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en-SG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nnectivity network (CNET) plots were created using </a:t>
            </a:r>
            <a:r>
              <a:rPr lang="en-US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enrichplo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package where the enriched pathways are represented by their respective colors. The enriched pathways were represented by their respective colors and corresponding gene associated with the pathway. 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41732470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1247D4D6-4687-45D6-536D-042B68B0B8A1}"/>
              </a:ext>
            </a:extLst>
          </p:cNvPr>
          <p:cNvSpPr txBox="1"/>
          <p:nvPr/>
        </p:nvSpPr>
        <p:spPr>
          <a:xfrm>
            <a:off x="427153" y="1603361"/>
            <a:ext cx="2808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2D68EE1-801B-FD43-AD2C-9874A3253233}"/>
              </a:ext>
            </a:extLst>
          </p:cNvPr>
          <p:cNvSpPr txBox="1"/>
          <p:nvPr/>
        </p:nvSpPr>
        <p:spPr>
          <a:xfrm>
            <a:off x="425169" y="105790"/>
            <a:ext cx="606117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: Single-cell RNA sequencing of Sydenham chorea versus controls </a:t>
            </a:r>
          </a:p>
          <a:p>
            <a:pPr marL="228600" indent="-228600">
              <a:buAutoNum type="alphaUcParenR"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umber of features, counts and mitochondrial percentage across samples</a:t>
            </a:r>
          </a:p>
          <a:p>
            <a:pPr marL="228600" indent="-228600">
              <a:buAutoNum type="alphaUcParenR"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oportion of individual cell types across samples</a:t>
            </a:r>
          </a:p>
          <a:p>
            <a:pPr marL="228600" indent="-228600">
              <a:buAutoNum type="alphaUcParenR"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eat map showing gene markers per cell type</a:t>
            </a:r>
          </a:p>
          <a:p>
            <a:pPr marL="228600" indent="-228600">
              <a:buAutoNum type="alphaUcParenR"/>
            </a:pPr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UMAP (Uniform Manifold Approximation and Projection) revealed nine distinct cell cluster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</p:txBody>
      </p:sp>
      <p:pic>
        <p:nvPicPr>
          <p:cNvPr id="5" name="Picture 4" descr="A diagram of dna analysis&#10;&#10;AI-generated content may be incorrect.">
            <a:extLst>
              <a:ext uri="{FF2B5EF4-FFF2-40B4-BE49-F238E27FC236}">
                <a16:creationId xmlns:a16="http://schemas.microsoft.com/office/drawing/2014/main" id="{D62F1221-F92D-6AA3-9A73-0A11CE7B0567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27631"/>
          <a:stretch/>
        </p:blipFill>
        <p:spPr>
          <a:xfrm>
            <a:off x="707999" y="1671646"/>
            <a:ext cx="3948714" cy="1249864"/>
          </a:xfrm>
          <a:prstGeom prst="rect">
            <a:avLst/>
          </a:prstGeom>
        </p:spPr>
      </p:pic>
      <p:pic>
        <p:nvPicPr>
          <p:cNvPr id="15" name="Picture 14" descr="A close-up of a purple and yellow pattern&#10;&#10;AI-generated content may be incorrect.">
            <a:extLst>
              <a:ext uri="{FF2B5EF4-FFF2-40B4-BE49-F238E27FC236}">
                <a16:creationId xmlns:a16="http://schemas.microsoft.com/office/drawing/2014/main" id="{5FFED2BD-C0EA-8EEF-C7D6-610382DEDB5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4077" y="5004428"/>
            <a:ext cx="5151435" cy="2442072"/>
          </a:xfrm>
          <a:prstGeom prst="rect">
            <a:avLst/>
          </a:prstGeom>
        </p:spPr>
      </p:pic>
      <p:pic>
        <p:nvPicPr>
          <p:cNvPr id="17" name="Picture 16" descr="A graph of different colored bars&#10;&#10;AI-generated content may be incorrect.">
            <a:extLst>
              <a:ext uri="{FF2B5EF4-FFF2-40B4-BE49-F238E27FC236}">
                <a16:creationId xmlns:a16="http://schemas.microsoft.com/office/drawing/2014/main" id="{48CE8D60-E814-3892-16EA-4ECA1923536B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60903" b="13732"/>
          <a:stretch/>
        </p:blipFill>
        <p:spPr>
          <a:xfrm>
            <a:off x="571141" y="3296479"/>
            <a:ext cx="1650851" cy="1634171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D5D87C3E-8C24-ACC6-748D-73B796688731}"/>
              </a:ext>
            </a:extLst>
          </p:cNvPr>
          <p:cNvSpPr txBox="1"/>
          <p:nvPr/>
        </p:nvSpPr>
        <p:spPr>
          <a:xfrm>
            <a:off x="434284" y="3157980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F744951-D521-C60D-0369-BF2DC2E5C05D}"/>
              </a:ext>
            </a:extLst>
          </p:cNvPr>
          <p:cNvSpPr txBox="1"/>
          <p:nvPr/>
        </p:nvSpPr>
        <p:spPr>
          <a:xfrm>
            <a:off x="431409" y="5183372"/>
            <a:ext cx="2936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90FA858-A70C-8408-1269-A13827F8FF77}"/>
              </a:ext>
            </a:extLst>
          </p:cNvPr>
          <p:cNvSpPr txBox="1"/>
          <p:nvPr/>
        </p:nvSpPr>
        <p:spPr>
          <a:xfrm flipH="1">
            <a:off x="1572767" y="1850200"/>
            <a:ext cx="384047" cy="120032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A556F0D-CEF1-28AC-5271-818DB33C3EFA}"/>
              </a:ext>
            </a:extLst>
          </p:cNvPr>
          <p:cNvSpPr txBox="1"/>
          <p:nvPr/>
        </p:nvSpPr>
        <p:spPr>
          <a:xfrm flipH="1">
            <a:off x="2922716" y="1877930"/>
            <a:ext cx="384047" cy="120032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3F84F88-7555-EF79-0B39-5E1BA98497BF}"/>
              </a:ext>
            </a:extLst>
          </p:cNvPr>
          <p:cNvSpPr txBox="1"/>
          <p:nvPr/>
        </p:nvSpPr>
        <p:spPr>
          <a:xfrm flipH="1">
            <a:off x="4153242" y="1845642"/>
            <a:ext cx="624439" cy="120032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  <p:pic>
        <p:nvPicPr>
          <p:cNvPr id="23" name="Picture 22" descr="A graph of different colored bars&#10;&#10;AI-generated content may be incorrect.">
            <a:extLst>
              <a:ext uri="{FF2B5EF4-FFF2-40B4-BE49-F238E27FC236}">
                <a16:creationId xmlns:a16="http://schemas.microsoft.com/office/drawing/2014/main" id="{EE4C8CBA-8824-BAA8-933E-75CEAC9FEE21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67733" b="13732"/>
          <a:stretch/>
        </p:blipFill>
        <p:spPr>
          <a:xfrm>
            <a:off x="2241488" y="3296478"/>
            <a:ext cx="1362456" cy="1634171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E3033A17-D01A-9C45-4ED3-31C6429A8329}"/>
              </a:ext>
            </a:extLst>
          </p:cNvPr>
          <p:cNvSpPr txBox="1"/>
          <p:nvPr/>
        </p:nvSpPr>
        <p:spPr>
          <a:xfrm>
            <a:off x="1078992" y="4765738"/>
            <a:ext cx="42976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/>
              <a:t>Control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97CA7A5-F90B-1B00-57AE-B49ECB05C097}"/>
              </a:ext>
            </a:extLst>
          </p:cNvPr>
          <p:cNvSpPr txBox="1"/>
          <p:nvPr/>
        </p:nvSpPr>
        <p:spPr>
          <a:xfrm>
            <a:off x="1660240" y="4770310"/>
            <a:ext cx="42976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/>
              <a:t>Control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1DFD0B9-CC54-3721-534C-2F2776C774EA}"/>
              </a:ext>
            </a:extLst>
          </p:cNvPr>
          <p:cNvSpPr txBox="1"/>
          <p:nvPr/>
        </p:nvSpPr>
        <p:spPr>
          <a:xfrm>
            <a:off x="2278062" y="4765738"/>
            <a:ext cx="538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/>
              <a:t>SC patient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141E9F7-ACE4-2813-5E89-EB64F42C2F92}"/>
              </a:ext>
            </a:extLst>
          </p:cNvPr>
          <p:cNvSpPr txBox="1"/>
          <p:nvPr/>
        </p:nvSpPr>
        <p:spPr>
          <a:xfrm rot="18837466">
            <a:off x="736169" y="2932760"/>
            <a:ext cx="42976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/>
              <a:t>Control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571022A-5EFE-02A8-56BA-1CA58875C00D}"/>
              </a:ext>
            </a:extLst>
          </p:cNvPr>
          <p:cNvSpPr txBox="1"/>
          <p:nvPr/>
        </p:nvSpPr>
        <p:spPr>
          <a:xfrm rot="18837466">
            <a:off x="952577" y="2920568"/>
            <a:ext cx="42976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/>
              <a:t>Control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26D40F5-B2DE-9DB6-082C-45395365E43E}"/>
              </a:ext>
            </a:extLst>
          </p:cNvPr>
          <p:cNvSpPr txBox="1"/>
          <p:nvPr/>
        </p:nvSpPr>
        <p:spPr>
          <a:xfrm rot="18837466">
            <a:off x="1073795" y="2936933"/>
            <a:ext cx="58532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/>
              <a:t>SC patient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FA02042-E01E-2C6E-81C3-C38B98DF42A5}"/>
              </a:ext>
            </a:extLst>
          </p:cNvPr>
          <p:cNvSpPr txBox="1"/>
          <p:nvPr/>
        </p:nvSpPr>
        <p:spPr>
          <a:xfrm rot="18837466">
            <a:off x="2112729" y="2913356"/>
            <a:ext cx="42976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/>
              <a:t>Control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CD0B735-D5D7-627A-A326-9246ED072010}"/>
              </a:ext>
            </a:extLst>
          </p:cNvPr>
          <p:cNvSpPr txBox="1"/>
          <p:nvPr/>
        </p:nvSpPr>
        <p:spPr>
          <a:xfrm rot="18837466">
            <a:off x="2310708" y="2916284"/>
            <a:ext cx="42976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/>
              <a:t>Control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875B594-EDBB-A7FC-8E5C-3DCFB77C4A95}"/>
              </a:ext>
            </a:extLst>
          </p:cNvPr>
          <p:cNvSpPr txBox="1"/>
          <p:nvPr/>
        </p:nvSpPr>
        <p:spPr>
          <a:xfrm rot="18837466">
            <a:off x="2426159" y="2926897"/>
            <a:ext cx="58532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/>
              <a:t>SC patient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5E48CEC-2CED-7114-D067-AE5D8FB580F3}"/>
              </a:ext>
            </a:extLst>
          </p:cNvPr>
          <p:cNvSpPr txBox="1"/>
          <p:nvPr/>
        </p:nvSpPr>
        <p:spPr>
          <a:xfrm rot="18837466">
            <a:off x="3344290" y="2909236"/>
            <a:ext cx="42976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/>
              <a:t>Control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A46E4EB-445F-FC24-6D97-1F502C5624E4}"/>
              </a:ext>
            </a:extLst>
          </p:cNvPr>
          <p:cNvSpPr txBox="1"/>
          <p:nvPr/>
        </p:nvSpPr>
        <p:spPr>
          <a:xfrm rot="18837466">
            <a:off x="3537880" y="2905114"/>
            <a:ext cx="42976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/>
              <a:t>Control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09B5AA3-CD5E-1293-5BB8-221E944569AA}"/>
              </a:ext>
            </a:extLst>
          </p:cNvPr>
          <p:cNvSpPr txBox="1"/>
          <p:nvPr/>
        </p:nvSpPr>
        <p:spPr>
          <a:xfrm rot="18837466">
            <a:off x="3649483" y="2931014"/>
            <a:ext cx="58532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/>
              <a:t>SC patient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80B4804-33D0-3B83-CF06-4AD1665376C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7762" y="7700517"/>
            <a:ext cx="2549001" cy="198797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25E30B9-B238-F416-5CA8-EC856A278429}"/>
              </a:ext>
            </a:extLst>
          </p:cNvPr>
          <p:cNvSpPr txBox="1"/>
          <p:nvPr/>
        </p:nvSpPr>
        <p:spPr>
          <a:xfrm>
            <a:off x="514798" y="7561389"/>
            <a:ext cx="2936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7909647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752840B-5D4B-3922-6E7E-09203BF48C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985" y="1442985"/>
            <a:ext cx="6480000" cy="68475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13FD815-504E-E823-CB2B-6CC87CA40B5A}"/>
              </a:ext>
            </a:extLst>
          </p:cNvPr>
          <p:cNvSpPr txBox="1"/>
          <p:nvPr/>
        </p:nvSpPr>
        <p:spPr>
          <a:xfrm>
            <a:off x="631711" y="375919"/>
            <a:ext cx="559457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G" sz="1200" b="1" kern="1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upplementary Figure 2: Single cell-RNA sequencing in </a:t>
            </a:r>
            <a:r>
              <a:rPr lang="en-SG" sz="1200" b="1" kern="100" dirty="0">
                <a:solidFill>
                  <a:srgbClr val="222222"/>
                </a:solidFill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ydenham chorea versus control</a:t>
            </a:r>
            <a:r>
              <a:rPr lang="en-SG" sz="1200" b="1" kern="1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: Dot plot of significant GO pathways across cell types </a:t>
            </a:r>
          </a:p>
          <a:p>
            <a:endParaRPr lang="en-SG" sz="12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  <a:p>
            <a:r>
              <a:rPr lang="en-SG" sz="1200" kern="1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Bar plot of top 5 up-regulated (in red) and down-regulated (in blue) GSEA GO pathways</a:t>
            </a:r>
            <a:endParaRPr lang="en-SG" sz="12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97210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4</TotalTime>
  <Words>725</Words>
  <Application>Microsoft Macintosh PowerPoint</Application>
  <PresentationFormat>A4 Paper (210x297 mm)</PresentationFormat>
  <Paragraphs>4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lda Han</dc:creator>
  <cp:lastModifiedBy>Velda Han</cp:lastModifiedBy>
  <cp:revision>43</cp:revision>
  <dcterms:created xsi:type="dcterms:W3CDTF">2025-02-27T06:52:39Z</dcterms:created>
  <dcterms:modified xsi:type="dcterms:W3CDTF">2025-05-31T14:13:51Z</dcterms:modified>
</cp:coreProperties>
</file>